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6858000" cy="9144000" type="letter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yse" initials="M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7DDA"/>
    <a:srgbClr val="FF9953"/>
    <a:srgbClr val="04481B"/>
    <a:srgbClr val="056726"/>
    <a:srgbClr val="079D39"/>
    <a:srgbClr val="00FF00"/>
    <a:srgbClr val="FF6600"/>
    <a:srgbClr val="CC3300"/>
    <a:srgbClr val="F9D6B9"/>
    <a:srgbClr val="F38E07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228600" y="2286000"/>
          <a:ext cx="6324601" cy="4724404"/>
        </p:xfrm>
        <a:graphic>
          <a:graphicData uri="http://schemas.openxmlformats.org/drawingml/2006/table">
            <a:tbl>
              <a:tblPr/>
              <a:tblGrid>
                <a:gridCol w="560320"/>
                <a:gridCol w="2792480"/>
                <a:gridCol w="1208210"/>
                <a:gridCol w="1763591"/>
              </a:tblGrid>
              <a:tr h="18428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Nam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Sequenc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Used</a:t>
                      </a:r>
                      <a:r>
                        <a:rPr lang="en-US" sz="1100" b="1" cap="none" baseline="0" dirty="0" smtClean="0">
                          <a:latin typeface="Courier"/>
                          <a:ea typeface="Cambria"/>
                          <a:cs typeface="Times New Roman"/>
                        </a:rPr>
                        <a:t> for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100" b="1" cap="none" dirty="0" err="1" smtClean="0">
                          <a:latin typeface="Courier"/>
                          <a:ea typeface="Cambria"/>
                          <a:cs typeface="Times New Roman"/>
                        </a:rPr>
                        <a:t>Cloned</a:t>
                      </a:r>
                      <a:r>
                        <a:rPr lang="fr-FR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 in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754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TAGCTGTTTTACAACTGCAATGTCTCCTCCACA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5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  <a:endParaRPr lang="fr-FR" sz="1000" b="0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TGTGGAGGAGACATTGCAGTTGTAAAACAGCTA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ACTAGAATGTCTGCTCCACAACAAATA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TATTTGTTGTGGAGCAGACATTCTAGT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TATAGGTGCAGGAGCAGTAGCTAGCTGTTTT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9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AAAACAGCTAGCTACTGCTCCTGCACCTA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0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CCAGTAGCTAGCTGTGCTACAACTAGAATGTC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1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GACATTCTAGTTGTAGCACAGCTAGCTACTGG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CGGCGGATTCGCAGCTCCCCCTACTGAAC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i="1" cap="none" dirty="0">
                          <a:latin typeface="Courier"/>
                          <a:ea typeface="Calibri"/>
                          <a:cs typeface="Times New Roman"/>
                        </a:rPr>
                        <a:t>Pf</a:t>
                      </a: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TTCAGTAGGGGGAGCTGCGAATCCGCCG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4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AGACATGCAGGAGCTATGATTCCAGATA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TATCTGGAATCATAGCTCCTGCATGTCT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GCAGGAAACATGGCCCCAGACAACGATAA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TTATCGTTGTCTGGGGCCATGTTTCCTGC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2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ATAAGAACTCCAACGCCAAGTATCCCGCCG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3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CGGCGGGATACTTGGCGTTGGAGTTCT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53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AATGTCACATCCTGGCTATTGCCGCTCAGGAA 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536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TTCCTGAGCGGCAATAGCCAGGATGTGACATT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2</TotalTime>
  <Words>88</Words>
  <Application>Microsoft Office PowerPoint</Application>
  <PresentationFormat>Format US (216 x 279 mm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Diapositiv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elle</dc:creator>
  <cp:lastModifiedBy>Maryse</cp:lastModifiedBy>
  <cp:revision>434</cp:revision>
  <cp:lastPrinted>2011-06-14T08:21:48Z</cp:lastPrinted>
  <dcterms:created xsi:type="dcterms:W3CDTF">2011-06-14T08:21:34Z</dcterms:created>
  <dcterms:modified xsi:type="dcterms:W3CDTF">2012-05-10T12:24:34Z</dcterms:modified>
</cp:coreProperties>
</file>